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7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8F75D472-9772-9E4B-B4A5-10FD92F8AEBB}" v="3" dt="2023-06-29T23:03:37.271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32"/>
    <p:restoredTop sz="94694"/>
  </p:normalViewPr>
  <p:slideViewPr>
    <p:cSldViewPr snapToGrid="0">
      <p:cViewPr>
        <p:scale>
          <a:sx n="100" d="100"/>
          <a:sy n="100" d="100"/>
        </p:scale>
        <p:origin x="2672" y="-10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藤井 匡" userId="d0175c71-90dd-4236-b482-6b7f6a599ccb" providerId="ADAL" clId="{8F75D472-9772-9E4B-B4A5-10FD92F8AEBB}"/>
    <pc:docChg chg="custSel delSld modSld">
      <pc:chgData name="藤井 匡" userId="d0175c71-90dd-4236-b482-6b7f6a599ccb" providerId="ADAL" clId="{8F75D472-9772-9E4B-B4A5-10FD92F8AEBB}" dt="2023-06-29T23:09:46.164" v="50" actId="20577"/>
      <pc:docMkLst>
        <pc:docMk/>
      </pc:docMkLst>
      <pc:sldChg chg="del">
        <pc:chgData name="藤井 匡" userId="d0175c71-90dd-4236-b482-6b7f6a599ccb" providerId="ADAL" clId="{8F75D472-9772-9E4B-B4A5-10FD92F8AEBB}" dt="2023-06-29T05:14:49.025" v="0" actId="2696"/>
        <pc:sldMkLst>
          <pc:docMk/>
          <pc:sldMk cId="752693718" sldId="256"/>
        </pc:sldMkLst>
      </pc:sldChg>
      <pc:sldChg chg="addSp delSp modSp mod">
        <pc:chgData name="藤井 匡" userId="d0175c71-90dd-4236-b482-6b7f6a599ccb" providerId="ADAL" clId="{8F75D472-9772-9E4B-B4A5-10FD92F8AEBB}" dt="2023-06-29T23:09:46.164" v="50" actId="20577"/>
        <pc:sldMkLst>
          <pc:docMk/>
          <pc:sldMk cId="1660982188" sldId="257"/>
        </pc:sldMkLst>
        <pc:spChg chg="del">
          <ac:chgData name="藤井 匡" userId="d0175c71-90dd-4236-b482-6b7f6a599ccb" providerId="ADAL" clId="{8F75D472-9772-9E4B-B4A5-10FD92F8AEBB}" dt="2023-06-29T05:14:52.090" v="1" actId="478"/>
          <ac:spMkLst>
            <pc:docMk/>
            <pc:sldMk cId="1660982188" sldId="257"/>
            <ac:spMk id="2" creationId="{97B91C31-6228-8A5A-E404-14CDDEE234DA}"/>
          </ac:spMkLst>
        </pc:spChg>
        <pc:spChg chg="add mod">
          <ac:chgData name="藤井 匡" userId="d0175c71-90dd-4236-b482-6b7f6a599ccb" providerId="ADAL" clId="{8F75D472-9772-9E4B-B4A5-10FD92F8AEBB}" dt="2023-06-29T23:09:46.164" v="50" actId="20577"/>
          <ac:spMkLst>
            <pc:docMk/>
            <pc:sldMk cId="1660982188" sldId="257"/>
            <ac:spMk id="3" creationId="{98968C53-37D0-9B38-C8C2-6C5928B8616A}"/>
          </ac:spMkLst>
        </pc:spChg>
      </pc:sldChg>
    </pc:docChg>
  </pc:docChgLst>
  <pc:docChgLst>
    <pc:chgData name="藤井 匡" userId="d0175c71-90dd-4236-b482-6b7f6a599ccb" providerId="ADAL" clId="{31A66B9B-A4BA-A846-B6C8-9E5957F70A19}"/>
    <pc:docChg chg="custSel modSld">
      <pc:chgData name="藤井 匡" userId="d0175c71-90dd-4236-b482-6b7f6a599ccb" providerId="ADAL" clId="{31A66B9B-A4BA-A846-B6C8-9E5957F70A19}" dt="2023-06-05T06:44:03.928" v="28" actId="20577"/>
      <pc:docMkLst>
        <pc:docMk/>
      </pc:docMkLst>
      <pc:sldChg chg="addSp delSp modSp mod">
        <pc:chgData name="藤井 匡" userId="d0175c71-90dd-4236-b482-6b7f6a599ccb" providerId="ADAL" clId="{31A66B9B-A4BA-A846-B6C8-9E5957F70A19}" dt="2023-06-05T06:43:56.487" v="25" actId="478"/>
        <pc:sldMkLst>
          <pc:docMk/>
          <pc:sldMk cId="752693718" sldId="256"/>
        </pc:sldMkLst>
        <pc:spChg chg="add mod">
          <ac:chgData name="藤井 匡" userId="d0175c71-90dd-4236-b482-6b7f6a599ccb" providerId="ADAL" clId="{31A66B9B-A4BA-A846-B6C8-9E5957F70A19}" dt="2023-06-05T06:43:50.318" v="23" actId="20577"/>
          <ac:spMkLst>
            <pc:docMk/>
            <pc:sldMk cId="752693718" sldId="256"/>
            <ac:spMk id="2" creationId="{4AF061D8-38E8-B871-F8EF-C0F4F0327E49}"/>
          </ac:spMkLst>
        </pc:spChg>
        <pc:spChg chg="add del mod">
          <ac:chgData name="藤井 匡" userId="d0175c71-90dd-4236-b482-6b7f6a599ccb" providerId="ADAL" clId="{31A66B9B-A4BA-A846-B6C8-9E5957F70A19}" dt="2023-06-05T06:43:56.487" v="25" actId="478"/>
          <ac:spMkLst>
            <pc:docMk/>
            <pc:sldMk cId="752693718" sldId="256"/>
            <ac:spMk id="3" creationId="{F9FFA3BD-B2F2-C1AB-191C-6516ABEFDF44}"/>
          </ac:spMkLst>
        </pc:spChg>
        <pc:spChg chg="del mod">
          <ac:chgData name="藤井 匡" userId="d0175c71-90dd-4236-b482-6b7f6a599ccb" providerId="ADAL" clId="{31A66B9B-A4BA-A846-B6C8-9E5957F70A19}" dt="2023-06-05T06:43:29.652" v="12" actId="478"/>
          <ac:spMkLst>
            <pc:docMk/>
            <pc:sldMk cId="752693718" sldId="256"/>
            <ac:spMk id="5" creationId="{84DFEACD-BA69-2CC2-E7E9-82337F3A1AD4}"/>
          </ac:spMkLst>
        </pc:spChg>
      </pc:sldChg>
      <pc:sldChg chg="addSp delSp modSp mod">
        <pc:chgData name="藤井 匡" userId="d0175c71-90dd-4236-b482-6b7f6a599ccb" providerId="ADAL" clId="{31A66B9B-A4BA-A846-B6C8-9E5957F70A19}" dt="2023-06-05T06:44:03.928" v="28" actId="20577"/>
        <pc:sldMkLst>
          <pc:docMk/>
          <pc:sldMk cId="1660982188" sldId="257"/>
        </pc:sldMkLst>
        <pc:spChg chg="add mod">
          <ac:chgData name="藤井 匡" userId="d0175c71-90dd-4236-b482-6b7f6a599ccb" providerId="ADAL" clId="{31A66B9B-A4BA-A846-B6C8-9E5957F70A19}" dt="2023-06-05T06:44:03.928" v="28" actId="20577"/>
          <ac:spMkLst>
            <pc:docMk/>
            <pc:sldMk cId="1660982188" sldId="257"/>
            <ac:spMk id="2" creationId="{97B91C31-6228-8A5A-E404-14CDDEE234DA}"/>
          </ac:spMkLst>
        </pc:spChg>
        <pc:spChg chg="del mod">
          <ac:chgData name="藤井 匡" userId="d0175c71-90dd-4236-b482-6b7f6a599ccb" providerId="ADAL" clId="{31A66B9B-A4BA-A846-B6C8-9E5957F70A19}" dt="2023-06-05T06:43:34.935" v="14" actId="478"/>
          <ac:spMkLst>
            <pc:docMk/>
            <pc:sldMk cId="1660982188" sldId="257"/>
            <ac:spMk id="6" creationId="{8C147BF6-5C38-6A3B-D064-6B00AD12B7B7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EE0C5A-BDD9-D042-93C1-8222C8AA071A}" type="datetimeFigureOut">
              <a:rPr kumimoji="1" lang="ja-JP" altLang="en-US" smtClean="0"/>
              <a:t>2023/6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192173-56E7-3A40-9EA2-E240DC5A94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687781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EE0C5A-BDD9-D042-93C1-8222C8AA071A}" type="datetimeFigureOut">
              <a:rPr kumimoji="1" lang="ja-JP" altLang="en-US" smtClean="0"/>
              <a:t>2023/6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192173-56E7-3A40-9EA2-E240DC5A94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84772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EE0C5A-BDD9-D042-93C1-8222C8AA071A}" type="datetimeFigureOut">
              <a:rPr kumimoji="1" lang="ja-JP" altLang="en-US" smtClean="0"/>
              <a:t>2023/6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192173-56E7-3A40-9EA2-E240DC5A94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353256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EE0C5A-BDD9-D042-93C1-8222C8AA071A}" type="datetimeFigureOut">
              <a:rPr kumimoji="1" lang="ja-JP" altLang="en-US" smtClean="0"/>
              <a:t>2023/6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192173-56E7-3A40-9EA2-E240DC5A94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67533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EE0C5A-BDD9-D042-93C1-8222C8AA071A}" type="datetimeFigureOut">
              <a:rPr kumimoji="1" lang="ja-JP" altLang="en-US" smtClean="0"/>
              <a:t>2023/6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192173-56E7-3A40-9EA2-E240DC5A94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132654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EE0C5A-BDD9-D042-93C1-8222C8AA071A}" type="datetimeFigureOut">
              <a:rPr kumimoji="1" lang="ja-JP" altLang="en-US" smtClean="0"/>
              <a:t>2023/6/3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192173-56E7-3A40-9EA2-E240DC5A94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396242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EE0C5A-BDD9-D042-93C1-8222C8AA071A}" type="datetimeFigureOut">
              <a:rPr kumimoji="1" lang="ja-JP" altLang="en-US" smtClean="0"/>
              <a:t>2023/6/3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192173-56E7-3A40-9EA2-E240DC5A94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301190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EE0C5A-BDD9-D042-93C1-8222C8AA071A}" type="datetimeFigureOut">
              <a:rPr kumimoji="1" lang="ja-JP" altLang="en-US" smtClean="0"/>
              <a:t>2023/6/3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192173-56E7-3A40-9EA2-E240DC5A94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284973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EE0C5A-BDD9-D042-93C1-8222C8AA071A}" type="datetimeFigureOut">
              <a:rPr kumimoji="1" lang="ja-JP" altLang="en-US" smtClean="0"/>
              <a:t>2023/6/3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192173-56E7-3A40-9EA2-E240DC5A94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73500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EE0C5A-BDD9-D042-93C1-8222C8AA071A}" type="datetimeFigureOut">
              <a:rPr kumimoji="1" lang="ja-JP" altLang="en-US" smtClean="0"/>
              <a:t>2023/6/3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192173-56E7-3A40-9EA2-E240DC5A94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823090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EE0C5A-BDD9-D042-93C1-8222C8AA071A}" type="datetimeFigureOut">
              <a:rPr kumimoji="1" lang="ja-JP" altLang="en-US" smtClean="0"/>
              <a:t>2023/6/3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192173-56E7-3A40-9EA2-E240DC5A94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396348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EE0C5A-BDD9-D042-93C1-8222C8AA071A}" type="datetimeFigureOut">
              <a:rPr kumimoji="1" lang="ja-JP" altLang="en-US" smtClean="0"/>
              <a:t>2023/6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192173-56E7-3A40-9EA2-E240DC5A94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696748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0DE8CEEF-7478-96EE-DF24-D97C7EE166D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68107" y="3636501"/>
            <a:ext cx="5613400" cy="2146300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98968C53-37D0-9B38-C8C2-6C5928B8616A}"/>
              </a:ext>
            </a:extLst>
          </p:cNvPr>
          <p:cNvSpPr txBox="1"/>
          <p:nvPr/>
        </p:nvSpPr>
        <p:spPr>
          <a:xfrm>
            <a:off x="518653" y="6175009"/>
            <a:ext cx="5262715" cy="9002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. S2. </a:t>
            </a:r>
            <a:r>
              <a:rPr lang="en-US" altLang="ja-JP" sz="105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ucleotide Sequence alignment of GH32 gene from </a:t>
            </a:r>
            <a:r>
              <a:rPr lang="en-US" altLang="ja-JP" sz="105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. </a:t>
            </a:r>
            <a:r>
              <a:rPr lang="en-US" altLang="ja-JP" sz="1050" i="1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oldsteinii</a:t>
            </a:r>
            <a:r>
              <a:rPr lang="en-US" altLang="ja-JP" sz="105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05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en-US" altLang="ja-JP" sz="105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Bacteroides fragilis</a:t>
            </a:r>
            <a:r>
              <a:rPr lang="en-US" altLang="ja-JP" sz="105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The sequence shown above the alignment indicates the region selected for primer sequence design. CP081906.1: </a:t>
            </a:r>
            <a:r>
              <a:rPr lang="en-US" altLang="ja-JP" sz="105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. </a:t>
            </a:r>
            <a:r>
              <a:rPr lang="en-US" altLang="ja-JP" sz="1050" i="1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oldsteinii</a:t>
            </a:r>
            <a:r>
              <a:rPr lang="en-US" altLang="ja-JP" sz="105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strain BFG-241, CP064353.1: </a:t>
            </a:r>
            <a:r>
              <a:rPr lang="en-US" altLang="ja-JP" sz="105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. </a:t>
            </a:r>
            <a:r>
              <a:rPr lang="en-US" altLang="ja-JP" sz="1050" i="1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oldsteinii</a:t>
            </a:r>
            <a:r>
              <a:rPr lang="en-US" altLang="ja-JP" sz="105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strain MTS01, CP036539.1: </a:t>
            </a:r>
            <a:r>
              <a:rPr lang="en-US" altLang="ja-JP" sz="105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. fragilis </a:t>
            </a:r>
            <a:r>
              <a:rPr lang="en-US" altLang="ja-JP" sz="105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train DCMOUH0017B, CP044428.1:</a:t>
            </a:r>
            <a:r>
              <a:rPr lang="en-US" altLang="ja-JP" sz="105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B. fragilis</a:t>
            </a:r>
            <a:r>
              <a:rPr lang="en-US" altLang="ja-JP" sz="105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strain DK1985</a:t>
            </a:r>
            <a:r>
              <a:rPr lang="ja-JP" altLang="ja-JP" sz="105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05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kumimoji="1" lang="ja-JP" altLang="en-US" sz="105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609821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9</TotalTime>
  <Words>65</Words>
  <Application>Microsoft Macintosh PowerPoint</Application>
  <PresentationFormat>ワイド画面</PresentationFormat>
  <Paragraphs>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藤井 匡</dc:creator>
  <cp:lastModifiedBy>藤井 匡</cp:lastModifiedBy>
  <cp:revision>1</cp:revision>
  <dcterms:created xsi:type="dcterms:W3CDTF">2023-05-14T00:44:08Z</dcterms:created>
  <dcterms:modified xsi:type="dcterms:W3CDTF">2023-06-29T23:09:50Z</dcterms:modified>
</cp:coreProperties>
</file>